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9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37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717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898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126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588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652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35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09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394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797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347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699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B77592-55B9-4C22-B085-14B9CEA8A5BF}" type="datetimeFigureOut">
              <a:rPr lang="en-US" smtClean="0"/>
              <a:t>1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24564-EEAA-47ED-B334-6A0FCBAA9F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7479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24047D35-58D0-445F-BE82-7B35DEDD7273}"/>
              </a:ext>
            </a:extLst>
          </p:cNvPr>
          <p:cNvSpPr txBox="1"/>
          <p:nvPr/>
        </p:nvSpPr>
        <p:spPr>
          <a:xfrm>
            <a:off x="226748" y="369712"/>
            <a:ext cx="500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73494AB-2759-4D65-A4BF-1FC363E22351}"/>
              </a:ext>
            </a:extLst>
          </p:cNvPr>
          <p:cNvSpPr txBox="1"/>
          <p:nvPr/>
        </p:nvSpPr>
        <p:spPr>
          <a:xfrm>
            <a:off x="3398443" y="369712"/>
            <a:ext cx="500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B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4821425-5BE9-4073-AF55-DC35A26DA208}"/>
              </a:ext>
            </a:extLst>
          </p:cNvPr>
          <p:cNvSpPr txBox="1"/>
          <p:nvPr/>
        </p:nvSpPr>
        <p:spPr>
          <a:xfrm>
            <a:off x="226748" y="3946044"/>
            <a:ext cx="5001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C</a:t>
            </a:r>
          </a:p>
        </p:txBody>
      </p:sp>
      <p:grpSp>
        <p:nvGrpSpPr>
          <p:cNvPr id="64" name="Group 63">
            <a:extLst>
              <a:ext uri="{FF2B5EF4-FFF2-40B4-BE49-F238E27FC236}">
                <a16:creationId xmlns:a16="http://schemas.microsoft.com/office/drawing/2014/main" id="{9C1CE1F2-964F-4201-BC4E-3672FB0AAE03}"/>
              </a:ext>
            </a:extLst>
          </p:cNvPr>
          <p:cNvGrpSpPr/>
          <p:nvPr/>
        </p:nvGrpSpPr>
        <p:grpSpPr>
          <a:xfrm>
            <a:off x="3801427" y="4572000"/>
            <a:ext cx="2528627" cy="1496552"/>
            <a:chOff x="9281088" y="2402919"/>
            <a:chExt cx="2528627" cy="1496552"/>
          </a:xfrm>
        </p:grpSpPr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ACF883C0-25CA-4927-8E0F-F915FEAA36F0}"/>
                </a:ext>
              </a:extLst>
            </p:cNvPr>
            <p:cNvGrpSpPr/>
            <p:nvPr/>
          </p:nvGrpSpPr>
          <p:grpSpPr>
            <a:xfrm>
              <a:off x="9281088" y="2402919"/>
              <a:ext cx="2464986" cy="1496552"/>
              <a:chOff x="8561805" y="3106102"/>
              <a:chExt cx="2464986" cy="1496552"/>
            </a:xfrm>
          </p:grpSpPr>
          <p:pic>
            <p:nvPicPr>
              <p:cNvPr id="70" name="Picture 69" descr="A close up of a logo&#10;&#10;Description automatically generated">
                <a:extLst>
                  <a:ext uri="{FF2B5EF4-FFF2-40B4-BE49-F238E27FC236}">
                    <a16:creationId xmlns:a16="http://schemas.microsoft.com/office/drawing/2014/main" id="{3A326700-5113-440E-A5A8-8FAB4669EE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-52378" b="56681"/>
              <a:stretch/>
            </p:blipFill>
            <p:spPr>
              <a:xfrm>
                <a:off x="8632915" y="3600184"/>
                <a:ext cx="2393876" cy="284238"/>
              </a:xfrm>
              <a:prstGeom prst="rect">
                <a:avLst/>
              </a:prstGeom>
            </p:spPr>
          </p:pic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CC930818-3BCF-40A7-BBB1-67A698DB0A0F}"/>
                  </a:ext>
                </a:extLst>
              </p:cNvPr>
              <p:cNvSpPr txBox="1"/>
              <p:nvPr/>
            </p:nvSpPr>
            <p:spPr>
              <a:xfrm>
                <a:off x="9018997" y="4023952"/>
                <a:ext cx="16063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200" b="1" kern="0" dirty="0">
                    <a:cs typeface="Arial" panose="020B0604020202020204" pitchFamily="34" charset="0"/>
                  </a:rPr>
                  <a:t>Tissue Level (1-5)</a:t>
                </a:r>
                <a:endParaRPr kumimoji="0" lang="en-US" sz="12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tangle: Rounded Corners 71">
                <a:extLst>
                  <a:ext uri="{FF2B5EF4-FFF2-40B4-BE49-F238E27FC236}">
                    <a16:creationId xmlns:a16="http://schemas.microsoft.com/office/drawing/2014/main" id="{80EE3ED4-EC5C-4E75-82E1-3CC6718A7A87}"/>
                  </a:ext>
                </a:extLst>
              </p:cNvPr>
              <p:cNvSpPr/>
              <p:nvPr/>
            </p:nvSpPr>
            <p:spPr>
              <a:xfrm rot="5400000">
                <a:off x="9739212" y="3723786"/>
                <a:ext cx="165906" cy="1326081"/>
              </a:xfrm>
              <a:prstGeom prst="roundRect">
                <a:avLst/>
              </a:prstGeom>
              <a:gradFill flip="none" rotWithShape="1">
                <a:gsLst>
                  <a:gs pos="0">
                    <a:srgbClr val="F2F8EE"/>
                  </a:gs>
                  <a:gs pos="77000">
                    <a:srgbClr val="C5DFB3"/>
                  </a:gs>
                  <a:gs pos="100000">
                    <a:schemeClr val="accent6">
                      <a:lumMod val="60000"/>
                      <a:lumOff val="40000"/>
                    </a:schemeClr>
                  </a:gs>
                </a:gsLst>
                <a:lin ang="16200000" scaled="1"/>
                <a:tileRect/>
              </a:gradFill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DAB5C7C8-4EF9-40A7-8BDA-FBDA2504113B}"/>
                  </a:ext>
                </a:extLst>
              </p:cNvPr>
              <p:cNvSpPr txBox="1"/>
              <p:nvPr/>
            </p:nvSpPr>
            <p:spPr>
              <a:xfrm>
                <a:off x="8775891" y="3476859"/>
                <a:ext cx="21079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200" b="1" kern="0" dirty="0">
                    <a:cs typeface="Arial" panose="020B0604020202020204" pitchFamily="34" charset="0"/>
                  </a:rPr>
                  <a:t>Spearman Correlation</a:t>
                </a:r>
                <a:endParaRPr kumimoji="0" lang="en-US" sz="1200" b="1" i="0" u="none" strike="noStrike" kern="0" cap="none" spc="0" normalizeH="0" baseline="0" noProof="0" dirty="0">
                  <a:ln>
                    <a:noFill/>
                  </a:ln>
                  <a:effectLst/>
                  <a:uLnTx/>
                  <a:uFillTx/>
                  <a:cs typeface="Arial" panose="020B0604020202020204" pitchFamily="34" charset="0"/>
                </a:endParaRPr>
              </a:p>
            </p:txBody>
          </p:sp>
          <p:sp>
            <p:nvSpPr>
              <p:cNvPr id="74" name="Rectangle 73">
                <a:extLst>
                  <a:ext uri="{FF2B5EF4-FFF2-40B4-BE49-F238E27FC236}">
                    <a16:creationId xmlns:a16="http://schemas.microsoft.com/office/drawing/2014/main" id="{C763F402-5850-41B9-8710-7ECD934E3EE4}"/>
                  </a:ext>
                </a:extLst>
              </p:cNvPr>
              <p:cNvSpPr/>
              <p:nvPr/>
            </p:nvSpPr>
            <p:spPr>
              <a:xfrm>
                <a:off x="8561805" y="3449563"/>
                <a:ext cx="2464986" cy="1153091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8737E297-D714-44D2-8119-787EEC458448}"/>
                  </a:ext>
                </a:extLst>
              </p:cNvPr>
              <p:cNvSpPr txBox="1"/>
              <p:nvPr/>
            </p:nvSpPr>
            <p:spPr>
              <a:xfrm>
                <a:off x="9224808" y="3106102"/>
                <a:ext cx="105113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algn="ctr">
                  <a:defRPr/>
                </a:pPr>
                <a:r>
                  <a:rPr lang="en-US" sz="1400" b="1" kern="0" dirty="0">
                    <a:cs typeface="Arial" panose="020B0604020202020204" pitchFamily="34" charset="0"/>
                  </a:rPr>
                  <a:t>Legend</a:t>
                </a:r>
              </a:p>
            </p:txBody>
          </p:sp>
        </p:grp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D479DDC1-8331-4F77-B943-CCBFF361B53D}"/>
                </a:ext>
              </a:extLst>
            </p:cNvPr>
            <p:cNvSpPr/>
            <p:nvPr/>
          </p:nvSpPr>
          <p:spPr>
            <a:xfrm>
              <a:off x="9352198" y="3190599"/>
              <a:ext cx="2328940" cy="12080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4157ABD0-BAC9-4BAA-A818-AC1309EE32FD}"/>
                </a:ext>
              </a:extLst>
            </p:cNvPr>
            <p:cNvSpPr txBox="1"/>
            <p:nvPr/>
          </p:nvSpPr>
          <p:spPr>
            <a:xfrm>
              <a:off x="9308288" y="3110859"/>
              <a:ext cx="5262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-1.0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EF47AAD8-5AFA-4092-98C8-F079560FA8C8}"/>
                </a:ext>
              </a:extLst>
            </p:cNvPr>
            <p:cNvSpPr txBox="1"/>
            <p:nvPr/>
          </p:nvSpPr>
          <p:spPr>
            <a:xfrm>
              <a:off x="10312412" y="3110859"/>
              <a:ext cx="5262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0.0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5B9D3694-745E-4686-AA52-924EBE53A66C}"/>
                </a:ext>
              </a:extLst>
            </p:cNvPr>
            <p:cNvSpPr txBox="1"/>
            <p:nvPr/>
          </p:nvSpPr>
          <p:spPr>
            <a:xfrm>
              <a:off x="11283506" y="3110859"/>
              <a:ext cx="5262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1.00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04B2A477-7A86-4E4E-B007-7D8165683CE7}"/>
              </a:ext>
            </a:extLst>
          </p:cNvPr>
          <p:cNvGrpSpPr/>
          <p:nvPr/>
        </p:nvGrpSpPr>
        <p:grpSpPr>
          <a:xfrm>
            <a:off x="566347" y="4112445"/>
            <a:ext cx="2712377" cy="3151570"/>
            <a:chOff x="544951" y="4112445"/>
            <a:chExt cx="2712377" cy="3151570"/>
          </a:xfrm>
        </p:grpSpPr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1C92E5D6-1C6F-4DFB-9CBA-E4934E6E33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80919"/>
            <a:stretch/>
          </p:blipFill>
          <p:spPr>
            <a:xfrm>
              <a:off x="582215" y="4520504"/>
              <a:ext cx="2639061" cy="608085"/>
            </a:xfrm>
            <a:prstGeom prst="rect">
              <a:avLst/>
            </a:prstGeom>
          </p:spPr>
        </p:pic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ED5AB4B-BA4B-4125-8CEA-B2C3D2553035}"/>
                </a:ext>
              </a:extLst>
            </p:cNvPr>
            <p:cNvSpPr txBox="1"/>
            <p:nvPr/>
          </p:nvSpPr>
          <p:spPr>
            <a:xfrm>
              <a:off x="859807" y="4112445"/>
              <a:ext cx="236596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/>
                <a:t>Bulk Tissue</a:t>
              </a:r>
            </a:p>
          </p:txBody>
        </p: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F66AAB7-B6C8-491C-804C-8B218881EAD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76686" y="5128589"/>
              <a:ext cx="2135426" cy="2135426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CD9065B3-0910-43E5-AEEA-462F7314FE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0349" r="84561" b="13839"/>
            <a:stretch/>
          </p:blipFill>
          <p:spPr>
            <a:xfrm>
              <a:off x="544951" y="5147660"/>
              <a:ext cx="407447" cy="2097284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5F0A4C09-B761-4F34-A7F8-19BA6BBEF1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5570" t="19902" b="18293"/>
            <a:stretch/>
          </p:blipFill>
          <p:spPr>
            <a:xfrm>
              <a:off x="3139312" y="5188410"/>
              <a:ext cx="118016" cy="2015784"/>
            </a:xfrm>
            <a:prstGeom prst="rect">
              <a:avLst/>
            </a:prstGeom>
          </p:spPr>
        </p:pic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5031A488-CA46-4BEF-AE06-CA452D60C05A}"/>
              </a:ext>
            </a:extLst>
          </p:cNvPr>
          <p:cNvGrpSpPr/>
          <p:nvPr/>
        </p:nvGrpSpPr>
        <p:grpSpPr>
          <a:xfrm>
            <a:off x="3886493" y="515558"/>
            <a:ext cx="2365964" cy="3080017"/>
            <a:chOff x="3829868" y="520559"/>
            <a:chExt cx="2365964" cy="3080017"/>
          </a:xfrm>
        </p:grpSpPr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BB151730-E285-42E0-8D8E-8BD126629E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76006" b="14174"/>
            <a:stretch/>
          </p:blipFill>
          <p:spPr>
            <a:xfrm>
              <a:off x="4096162" y="854798"/>
              <a:ext cx="436078" cy="2745778"/>
            </a:xfrm>
            <a:prstGeom prst="rect">
              <a:avLst/>
            </a:prstGeom>
          </p:spPr>
        </p:pic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FDBF5E6D-4574-43FD-9371-9DF96677744C}"/>
                </a:ext>
              </a:extLst>
            </p:cNvPr>
            <p:cNvSpPr txBox="1"/>
            <p:nvPr/>
          </p:nvSpPr>
          <p:spPr>
            <a:xfrm>
              <a:off x="3829868" y="520559"/>
              <a:ext cx="236596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/>
                <a:t>Enriched Stroma</a:t>
              </a:r>
            </a:p>
          </p:txBody>
        </p:sp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7F2BC4D1-ED00-48EF-AC1A-41FFA7221C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-1" r="15484" b="87493"/>
            <a:stretch/>
          </p:blipFill>
          <p:spPr>
            <a:xfrm>
              <a:off x="4101700" y="901894"/>
              <a:ext cx="1536055" cy="400111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40D6440B-ABA8-407C-8207-B54801DEF53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904" t="11654" r="12578" b="82278"/>
            <a:stretch/>
          </p:blipFill>
          <p:spPr>
            <a:xfrm>
              <a:off x="4174434" y="1317589"/>
              <a:ext cx="1536055" cy="194117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C9FF7160-4B11-4089-AA68-C835EF04375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5570" t="19902" b="18293"/>
            <a:stretch/>
          </p:blipFill>
          <p:spPr>
            <a:xfrm>
              <a:off x="5451464" y="1539002"/>
              <a:ext cx="118016" cy="2015784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DA674E7-E166-4E7F-8207-35AEBB5C318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543280" y="1509162"/>
              <a:ext cx="897143" cy="2069725"/>
            </a:xfrm>
            <a:prstGeom prst="rect">
              <a:avLst/>
            </a:prstGeom>
          </p:spPr>
        </p:pic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EAD6F815-290E-4E4E-BC26-8F476B572D8B}"/>
              </a:ext>
            </a:extLst>
          </p:cNvPr>
          <p:cNvGrpSpPr/>
          <p:nvPr/>
        </p:nvGrpSpPr>
        <p:grpSpPr>
          <a:xfrm>
            <a:off x="603005" y="520856"/>
            <a:ext cx="2639061" cy="3105478"/>
            <a:chOff x="661059" y="520856"/>
            <a:chExt cx="2639061" cy="3105478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969893B3-B716-43DF-A395-AA0599FE906A}"/>
                </a:ext>
              </a:extLst>
            </p:cNvPr>
            <p:cNvSpPr txBox="1"/>
            <p:nvPr/>
          </p:nvSpPr>
          <p:spPr>
            <a:xfrm>
              <a:off x="859807" y="520856"/>
              <a:ext cx="236596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/>
                <a:t>Enriched Tumor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43AE10C-5289-4E14-A4D0-764F1AA8F0B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100906" y="1529051"/>
              <a:ext cx="1996640" cy="1988960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DEA1E96A-DC3C-43C0-991D-57833BAB64F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80919"/>
            <a:stretch/>
          </p:blipFill>
          <p:spPr>
            <a:xfrm>
              <a:off x="661059" y="901894"/>
              <a:ext cx="2639061" cy="608085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8F821D45-C388-47B8-A33C-0A2B8A2236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0349" r="84561" b="13839"/>
            <a:stretch/>
          </p:blipFill>
          <p:spPr>
            <a:xfrm>
              <a:off x="687403" y="1529050"/>
              <a:ext cx="407447" cy="2097284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1CC42077-A410-47AC-AE62-F28FD6D802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5570" t="19902" b="18293"/>
            <a:stretch/>
          </p:blipFill>
          <p:spPr>
            <a:xfrm>
              <a:off x="3128616" y="1509979"/>
              <a:ext cx="118016" cy="201578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49347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Hunt</dc:creator>
  <cp:lastModifiedBy>Allison Hunt</cp:lastModifiedBy>
  <cp:revision>1</cp:revision>
  <dcterms:created xsi:type="dcterms:W3CDTF">2024-01-04T20:28:25Z</dcterms:created>
  <dcterms:modified xsi:type="dcterms:W3CDTF">2024-01-04T20:28:43Z</dcterms:modified>
</cp:coreProperties>
</file>